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94378" y="3339276"/>
            <a:ext cx="1796720" cy="173736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61444" y="1553304"/>
            <a:ext cx="1796720" cy="173736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21024" y="1552464"/>
            <a:ext cx="1665371" cy="17373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20315" y="3330890"/>
            <a:ext cx="1665371" cy="17373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13764" y="1541042"/>
            <a:ext cx="1721333" cy="17373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7200"/>
                    </a14:imgEffect>
                    <a14:imgEffect>
                      <a14:saturation sat="11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591" y="1748324"/>
            <a:ext cx="4260456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91153" y="4938702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76144" y="4938702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veh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04324" y="4938702"/>
            <a:ext cx="10005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NC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45375" y="4938702"/>
            <a:ext cx="11031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LPA</a:t>
            </a:r>
            <a:r>
              <a:rPr lang="en-US" altLang="ko-KR" sz="1000" baseline="-25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4687776" y="3292598"/>
            <a:ext cx="14542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  <a:r>
              <a:rPr lang="en-US" altLang="ko-KR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141541" y="2383982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110283" y="4114206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844903" y="4955772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10162" y="5197446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515897" y="495577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6307407" y="5195364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872811" y="4955772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255552" y="4961670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20"/>
          <p:cNvSpPr txBox="1"/>
          <p:nvPr/>
        </p:nvSpPr>
        <p:spPr>
          <a:xfrm>
            <a:off x="6204255" y="341145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503301" y="3330950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894902" y="40391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+mj-lt"/>
                <a:cs typeface="Arial" panose="020B0604020202020204" pitchFamily="34" charset="0"/>
              </a:rPr>
              <a:t>##</a:t>
            </a:r>
          </a:p>
        </p:txBody>
      </p:sp>
      <p:sp>
        <p:nvSpPr>
          <p:cNvPr id="22" name="TextBox 20"/>
          <p:cNvSpPr txBox="1"/>
          <p:nvPr/>
        </p:nvSpPr>
        <p:spPr>
          <a:xfrm>
            <a:off x="6210013" y="1614291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500433" y="1740818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943790" y="18710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49539" y="14187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102300" y="14187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618411" y="2005002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45680" y="1850886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228879" y="4321868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260137" y="3269654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11087" y="1933125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877974" y="1839391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00245" y="1947509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151800" y="1853775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853306" y="2160294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140963" y="1850905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982651" y="315860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0647910" y="3400280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653645" y="3158606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10445155" y="3398198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1010559" y="3158606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0393300" y="3164504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0"/>
          <p:cNvSpPr txBox="1"/>
          <p:nvPr/>
        </p:nvSpPr>
        <p:spPr>
          <a:xfrm>
            <a:off x="10356381" y="1654541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0707183" y="192771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5" name="TextBox 20"/>
          <p:cNvSpPr txBox="1"/>
          <p:nvPr/>
        </p:nvSpPr>
        <p:spPr>
          <a:xfrm>
            <a:off x="11080720" y="254615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+mj-lt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8950425" y="2325108"/>
            <a:ext cx="16770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tio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moeboid/ramified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Isosceles Triangle 46"/>
          <p:cNvSpPr/>
          <p:nvPr/>
        </p:nvSpPr>
        <p:spPr>
          <a:xfrm>
            <a:off x="2244377" y="4353585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>
            <a:off x="3687182" y="4388165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Isosceles Triangle 48"/>
          <p:cNvSpPr/>
          <p:nvPr/>
        </p:nvSpPr>
        <p:spPr>
          <a:xfrm>
            <a:off x="2144132" y="4639625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>
            <a:off x="3312047" y="4469994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>
            <a:off x="4665643" y="4265983"/>
            <a:ext cx="57528" cy="58826"/>
          </a:xfrm>
          <a:prstGeom prst="triangl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Isosceles Triangle 51"/>
          <p:cNvSpPr/>
          <p:nvPr/>
        </p:nvSpPr>
        <p:spPr>
          <a:xfrm>
            <a:off x="4563301" y="4042754"/>
            <a:ext cx="57528" cy="58826"/>
          </a:xfrm>
          <a:prstGeom prst="triangl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9439909" y="14187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6969446" y="3264577"/>
            <a:ext cx="11464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ma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ize (µm</a:t>
            </a:r>
            <a:r>
              <a:rPr lang="en-US" altLang="ko-K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7269321" y="2355961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7238063" y="4086185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8067633" y="496153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8732892" y="5203204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8738627" y="4961530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8530137" y="5201122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9095541" y="4961530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8478282" y="4967428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20"/>
          <p:cNvSpPr txBox="1"/>
          <p:nvPr/>
        </p:nvSpPr>
        <p:spPr>
          <a:xfrm>
            <a:off x="8386691" y="1755185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746119" y="183857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9" name="TextBox 20"/>
          <p:cNvSpPr txBox="1"/>
          <p:nvPr/>
        </p:nvSpPr>
        <p:spPr>
          <a:xfrm>
            <a:off x="9154160" y="221548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0" name="TextBox 20"/>
          <p:cNvSpPr txBox="1"/>
          <p:nvPr/>
        </p:nvSpPr>
        <p:spPr>
          <a:xfrm>
            <a:off x="8418327" y="335682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8769129" y="3595488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2" name="TextBox 20"/>
          <p:cNvSpPr txBox="1"/>
          <p:nvPr/>
        </p:nvSpPr>
        <p:spPr>
          <a:xfrm>
            <a:off x="9142666" y="405003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+mj-lt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7254558" y="142450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169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3</TotalTime>
  <Words>73</Words>
  <Application>Microsoft Office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92</cp:revision>
  <dcterms:created xsi:type="dcterms:W3CDTF">2019-06-25T05:43:47Z</dcterms:created>
  <dcterms:modified xsi:type="dcterms:W3CDTF">2019-07-14T13:24:39Z</dcterms:modified>
</cp:coreProperties>
</file>